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8" r:id="rId2"/>
    <p:sldId id="270" r:id="rId3"/>
    <p:sldId id="26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4748595-A025-C12E-2D16-064032F367A6}" name="Kim Martinod" initials="KM" userId="S::kim.martinod@kuleuven.be::00c657a1-3091-4f07-a6e3-f98def465bb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3" autoAdjust="0"/>
    <p:restoredTop sz="89344" autoAdjust="0"/>
  </p:normalViewPr>
  <p:slideViewPr>
    <p:cSldViewPr snapToGrid="0">
      <p:cViewPr varScale="1">
        <p:scale>
          <a:sx n="71" d="100"/>
          <a:sy n="71" d="100"/>
        </p:scale>
        <p:origin x="3352" y="184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7CF8F-EA88-484A-BC70-E66F1F3EE8AC}" type="datetimeFigureOut">
              <a:rPr lang="en-US" smtClean="0"/>
              <a:t>3/1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F97B6F-4E40-40EA-9295-F31546AA6F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5971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/>
              <a:t>Supplemental </a:t>
            </a:r>
            <a:r>
              <a:rPr lang="nl-BE" dirty="0" err="1"/>
              <a:t>Table</a:t>
            </a:r>
            <a:r>
              <a:rPr lang="nl-BE" dirty="0"/>
              <a:t>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F97B6F-4E40-40EA-9295-F31546AA6F1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6240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/>
              <a:t>Supplemental </a:t>
            </a:r>
            <a:r>
              <a:rPr lang="nl-BE" dirty="0" err="1"/>
              <a:t>Table</a:t>
            </a:r>
            <a:r>
              <a:rPr lang="nl-BE" dirty="0"/>
              <a:t>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F97B6F-4E40-40EA-9295-F31546AA6F1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6772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/>
              <a:t>Supplemental </a:t>
            </a:r>
            <a:r>
              <a:rPr lang="nl-BE" dirty="0" err="1"/>
              <a:t>Figure</a:t>
            </a:r>
            <a:r>
              <a:rPr lang="nl-BE" dirty="0"/>
              <a:t>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F97B6F-4E40-40EA-9295-F31546AA6F1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115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3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819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403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926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550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750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176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354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998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216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854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8C1F5C-14C7-462F-918E-E5A60C28A48A}" type="datetimeFigureOut">
              <a:rPr lang="en-US" smtClean="0"/>
              <a:t>3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D0CE1-7C65-40E2-A744-489F2841DA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09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C7713CB-AA03-4CDE-8EAE-C48D49765E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3683378"/>
              </p:ext>
            </p:extLst>
          </p:nvPr>
        </p:nvGraphicFramePr>
        <p:xfrm>
          <a:off x="1050524" y="1132396"/>
          <a:ext cx="4324811" cy="476304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53364">
                  <a:extLst>
                    <a:ext uri="{9D8B030D-6E8A-4147-A177-3AD203B41FA5}">
                      <a16:colId xmlns:a16="http://schemas.microsoft.com/office/drawing/2014/main" val="1430541726"/>
                    </a:ext>
                  </a:extLst>
                </a:gridCol>
                <a:gridCol w="1861647">
                  <a:extLst>
                    <a:ext uri="{9D8B030D-6E8A-4147-A177-3AD203B41FA5}">
                      <a16:colId xmlns:a16="http://schemas.microsoft.com/office/drawing/2014/main" val="1822260355"/>
                    </a:ext>
                  </a:extLst>
                </a:gridCol>
                <a:gridCol w="1709800">
                  <a:extLst>
                    <a:ext uri="{9D8B030D-6E8A-4147-A177-3AD203B41FA5}">
                      <a16:colId xmlns:a16="http://schemas.microsoft.com/office/drawing/2014/main" val="2544318130"/>
                    </a:ext>
                  </a:extLst>
                </a:gridCol>
              </a:tblGrid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Gene name</a:t>
                      </a:r>
                      <a:endParaRPr lang="en-US" sz="9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Forward primer</a:t>
                      </a:r>
                      <a:endParaRPr lang="en-US" sz="9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Reverse primer</a:t>
                      </a:r>
                      <a:endParaRPr lang="en-US" sz="9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7187310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Col3a1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AGGAATGGGTGGCTATCC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TGCGTCCATCAAAGCCTC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01974595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Timp3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TCGCGCCCCTATATCACT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AGTGCCTTCCAAGTAGCC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941259055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Padi4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TGCCTTTTCCTCTTGAGT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GTGGATGAGTTCT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086307162"/>
                  </a:ext>
                </a:extLst>
              </a:tr>
              <a:tr h="21593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Il6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GTCCTTCCTACCCCAATTTCCA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AACGCACTAGGTTTGCCG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3291070955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effectLst/>
                        </a:rPr>
                        <a:t>Nppa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GTCTTGGCCTTTTGGCTT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GTGGTCTAGCAGGTTCTTGAA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401004628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effectLst/>
                        </a:rPr>
                        <a:t>Nppb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CCAGTCTCCAGAGCAATTC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GCTGTCTCTGGGCCATTT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233590536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Acta2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TACCCAGGCATTGCTGAC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AGGCGCTGATCCACAAAA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908690319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Tgfb1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GTGGTATACTGAG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CCAAGGAAAGGTAGGT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497420159"/>
                  </a:ext>
                </a:extLst>
              </a:tr>
              <a:tr h="20950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Smad3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GCTTTGAGGCTGTCTACCAGCT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TGAGGACCTTGACAAGCCAC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1379079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Smad4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AGCCATAGTGAAGGACTGTTG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CTACTTCCAGTCCAGGTGGT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392838408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Timp4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GCCATTTGACTCTTCCC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ATAGCAAGTGGTGATTTGGCA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307209193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Timp2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CTGGACGTTGGAGGAAAG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ACAGCGAGTGATCTTGCA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172649053"/>
                  </a:ext>
                </a:extLst>
              </a:tr>
              <a:tr h="20072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Timp1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GAGACACACCAGAGCAGATACC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GGGAACCCATGAATTTAGC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25584724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Mmp3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CCTGCAACCGTGAAGAAG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ACAGCATCCACCCTTGAG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996911091"/>
                  </a:ext>
                </a:extLst>
              </a:tr>
              <a:tr h="17272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Mmp9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CTGACTACGATAAGGACGGC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AGTGGTGCAGGCAGAGTAGG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3880638829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effectLst/>
                        </a:rPr>
                        <a:t>Tnf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ATCGGTCCCCAAAGGGAT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TT TGC TAC GAC GTG GG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4212161008"/>
                  </a:ext>
                </a:extLst>
              </a:tr>
              <a:tr h="20445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Il1b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GGACCTTCCAGGATGAGGAC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TTCATCTCGGAGCCTGTAGT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242557244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Il10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GGGAAGACAATAACTGCACC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GGTTAGCAGTATGTTGTCCAG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182091949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effectLst/>
                        </a:rPr>
                        <a:t>Agt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TGGCGCTGAAGGATACAC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ATGTATACGCGGTCCCCA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533493598"/>
                  </a:ext>
                </a:extLst>
              </a:tr>
              <a:tr h="19683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Ccl3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CAACCAAGTCTTCTCAGC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CTCTTAGTCAGGAAAATGACAC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090001629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Ccl12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ACTGGTTCCTGACTCCTC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CTGAGGACTGATGGTGG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338731053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err="1">
                          <a:effectLst/>
                        </a:rPr>
                        <a:t>Ccn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CATCTCCACCCGAGTTAC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ACTTGACAGGCTTGGCGA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154169939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Col1a3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TTGCTGGCCTACATGGTG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TGAGTTCTTCGCTGGGGT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459529551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Mmp13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CAAGATGTGGAGTGCCTG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CCTTTGGAACTGCTTGTC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2440634940"/>
                  </a:ext>
                </a:extLst>
              </a:tr>
              <a:tr h="16892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</a:rPr>
                        <a:t>G</a:t>
                      </a:r>
                      <a:r>
                        <a:rPr lang="en-US" sz="800" i="1">
                          <a:effectLst/>
                        </a:rPr>
                        <a:t>apdh</a:t>
                      </a:r>
                      <a:endParaRPr lang="en-US" sz="8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CGCATCTTCTTGTGCAG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GAATTTGCCGTGAGTGGAGT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624" marR="51624" marT="0" marB="0"/>
                </a:tc>
                <a:extLst>
                  <a:ext uri="{0D108BD9-81ED-4DB2-BD59-A6C34878D82A}">
                    <a16:rowId xmlns:a16="http://schemas.microsoft.com/office/drawing/2014/main" val="121856277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B7E5777-2F1E-6B49-9245-811159982C80}"/>
              </a:ext>
            </a:extLst>
          </p:cNvPr>
          <p:cNvSpPr txBox="1"/>
          <p:nvPr/>
        </p:nvSpPr>
        <p:spPr>
          <a:xfrm>
            <a:off x="57600" y="92584"/>
            <a:ext cx="1902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5EB2011-D754-FB4B-BC88-55818C507752}"/>
              </a:ext>
            </a:extLst>
          </p:cNvPr>
          <p:cNvSpPr/>
          <p:nvPr/>
        </p:nvSpPr>
        <p:spPr>
          <a:xfrm>
            <a:off x="795000" y="6384039"/>
            <a:ext cx="4673600" cy="6164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le 1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-PCR primers used for cardiac gene expression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is</a:t>
            </a:r>
            <a:r>
              <a:rPr lang="en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BE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imers are listed from 5’ </a:t>
            </a:r>
            <a:r>
              <a:rPr lang="en-B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Wingdings" pitchFamily="2" charset="2"/>
              </a:rPr>
              <a:t></a:t>
            </a:r>
            <a:r>
              <a:rPr lang="en-BE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’.</a:t>
            </a:r>
            <a:endParaRPr lang="en-B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3444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B7E5777-2F1E-6B49-9245-811159982C80}"/>
              </a:ext>
            </a:extLst>
          </p:cNvPr>
          <p:cNvSpPr txBox="1"/>
          <p:nvPr/>
        </p:nvSpPr>
        <p:spPr>
          <a:xfrm>
            <a:off x="57600" y="92584"/>
            <a:ext cx="1902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Table </a:t>
            </a:r>
            <a:r>
              <a:rPr lang="nl-BE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B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5EB2011-D754-FB4B-BC88-55818C507752}"/>
              </a:ext>
            </a:extLst>
          </p:cNvPr>
          <p:cNvSpPr/>
          <p:nvPr/>
        </p:nvSpPr>
        <p:spPr>
          <a:xfrm>
            <a:off x="693400" y="5530599"/>
            <a:ext cx="4673600" cy="3395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le </a:t>
            </a:r>
            <a:r>
              <a:rPr lang="nl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– Echocardiography</a:t>
            </a:r>
            <a:r>
              <a:rPr lang="nl-B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ort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F2E31F1-8349-4628-80D7-72A98D87B9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1010761"/>
              </p:ext>
            </p:extLst>
          </p:nvPr>
        </p:nvGraphicFramePr>
        <p:xfrm>
          <a:off x="285750" y="545335"/>
          <a:ext cx="6329361" cy="469817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817370">
                  <a:extLst>
                    <a:ext uri="{9D8B030D-6E8A-4147-A177-3AD203B41FA5}">
                      <a16:colId xmlns:a16="http://schemas.microsoft.com/office/drawing/2014/main" val="1959654348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584807491"/>
                    </a:ext>
                  </a:extLst>
                </a:gridCol>
                <a:gridCol w="1192972">
                  <a:extLst>
                    <a:ext uri="{9D8B030D-6E8A-4147-A177-3AD203B41FA5}">
                      <a16:colId xmlns:a16="http://schemas.microsoft.com/office/drawing/2014/main" val="659896189"/>
                    </a:ext>
                  </a:extLst>
                </a:gridCol>
                <a:gridCol w="950952">
                  <a:extLst>
                    <a:ext uri="{9D8B030D-6E8A-4147-A177-3AD203B41FA5}">
                      <a16:colId xmlns:a16="http://schemas.microsoft.com/office/drawing/2014/main" val="122210855"/>
                    </a:ext>
                  </a:extLst>
                </a:gridCol>
                <a:gridCol w="1491767">
                  <a:extLst>
                    <a:ext uri="{9D8B030D-6E8A-4147-A177-3AD203B41FA5}">
                      <a16:colId xmlns:a16="http://schemas.microsoft.com/office/drawing/2014/main" val="2009037436"/>
                    </a:ext>
                  </a:extLst>
                </a:gridCol>
              </a:tblGrid>
              <a:tr h="35364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Young PAD4</a:t>
                      </a:r>
                      <a:r>
                        <a:rPr lang="en-US" sz="1100" baseline="30000">
                          <a:effectLst/>
                        </a:rPr>
                        <a:t>fl/f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Young PAD4</a:t>
                      </a:r>
                      <a:r>
                        <a:rPr lang="en-US" sz="1100" baseline="30000">
                          <a:effectLst/>
                        </a:rPr>
                        <a:t>fl/fl</a:t>
                      </a:r>
                      <a:r>
                        <a:rPr lang="en-US" sz="1100">
                          <a:effectLst/>
                        </a:rPr>
                        <a:t>MRP8Cre</a:t>
                      </a:r>
                      <a:r>
                        <a:rPr lang="en-US" sz="1100" baseline="30000">
                          <a:effectLst/>
                        </a:rPr>
                        <a:t>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Old PAD4</a:t>
                      </a:r>
                      <a:r>
                        <a:rPr lang="en-US" sz="1100" baseline="30000">
                          <a:effectLst/>
                        </a:rPr>
                        <a:t>fl/f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Old PAD4</a:t>
                      </a:r>
                      <a:r>
                        <a:rPr lang="en-US" sz="1100" baseline="30000">
                          <a:effectLst/>
                        </a:rPr>
                        <a:t>fl/fl</a:t>
                      </a:r>
                      <a:r>
                        <a:rPr lang="en-US" sz="1100">
                          <a:effectLst/>
                        </a:rPr>
                        <a:t>MRP8Cre</a:t>
                      </a:r>
                      <a:r>
                        <a:rPr lang="en-US" sz="1100" baseline="30000">
                          <a:effectLst/>
                        </a:rPr>
                        <a:t>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49468654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VEF (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7 ± 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6 ± 2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3 ± 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7 ± 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57128677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/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5 ± 0.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 ± 0.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2 ± 0.0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 ± 0.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54593355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/e’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8.72 ± 2.9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5.60 ± 4.2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8.52 ± 1.9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3.89 ± 3.9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12458771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FS (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6.29 ± 0.8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6.81 ± 2.3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7.61 ± 1.2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7.54 ± 2.8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75461304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V Vol(d) (µ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0.94 ± 5.9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9.54 ± 5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0.05 ± 3.7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9.09 ± 5.68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13672701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V Vol(s) (µ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8.99 ± 2.5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6.77 ± 2.1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2.50 ± 2.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1.67 ± 3.03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34978955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V Peak Vel (mm/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270 ± 1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173 ± 5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340 ± 6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218 ± 5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0552256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V desc vel (mm/s)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931 ± 4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962 ± 7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66 ± 4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53 ± 4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1515024"/>
                  </a:ext>
                </a:extLst>
              </a:tr>
              <a:tr h="35364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V peak pressure (mmHg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.57 ± 0.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.58 ± 0.5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.72 ± 0.7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.06 ± 0.5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33583821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VCT (m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9.59 ± 0.9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8.30 ± 0.8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0.84 ± 0.9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9.25 ± 1.3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00783482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VRT (m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7.30 ± 0.3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7.65 ± 0.7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9.31 ± 0.6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7.01 ± 0.4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07373166"/>
                  </a:ext>
                </a:extLst>
              </a:tr>
              <a:tr h="35364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V peak vel (mm/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16.00 ± 28.9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31.50 ± 36.3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92.80 ± 24.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24.00 ± 28.2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099672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AT (m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3.08 ± 0.8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2.65 ± 0.9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1.97 ± 1.1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3.07 ± 1.2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76070209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ET (m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2.72 ± 3.2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3.00 ± 6.3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5.92 ± 3.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4.81 ± 3.9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4806327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AT/PET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8 ± 0.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9 ± 0.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9 ± 0.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32 ± 0.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4929453"/>
                  </a:ext>
                </a:extLst>
              </a:tr>
              <a:tr h="35364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V peak press (mmHg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56 ± 0.1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64 ± 0.1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6 ± 0.1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60 ± 0.1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71704788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VS(d) (mm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22 ± 0.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12 ± 0.0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10 ± 0.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09 ± 0.0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24240158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VS(s) (mm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76 ± 0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54 ± 0.1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51 ± 0.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58 ± 0.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51628917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VID(d) (mm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58 ± 0.1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44 ± 0.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99 ± 0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72 ± 0.1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7580631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VID(s) (mm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29 ± 0.1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18 ± 0.1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88 ± 0.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42 ± 0.1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23593519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VPW(d) (mm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99 ± 0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92 ± 0.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00 ± 0.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06 ± 0.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77987271"/>
                  </a:ext>
                </a:extLst>
              </a:tr>
              <a:tr h="172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VPW(s) (mm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1 ± 0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38 ± 0.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36 ± 0.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53 ± 0.0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750700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4336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76D9D01-CB53-4B4A-ACE5-A0D146FAC7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6296035"/>
              </p:ext>
            </p:extLst>
          </p:nvPr>
        </p:nvGraphicFramePr>
        <p:xfrm>
          <a:off x="134517" y="1360234"/>
          <a:ext cx="2418918" cy="2605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4" name="Prism 9" r:id="rId4" imgW="2991220" imgH="3221297" progId="Prism9.Document">
                  <p:embed/>
                </p:oleObj>
              </mc:Choice>
              <mc:Fallback>
                <p:oleObj name="Prism 9" r:id="rId4" imgW="2991220" imgH="322129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4517" y="1360234"/>
                        <a:ext cx="2418918" cy="2605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42B9B99-FBB4-40E3-899C-ECDC8860FB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4854862"/>
              </p:ext>
            </p:extLst>
          </p:nvPr>
        </p:nvGraphicFramePr>
        <p:xfrm>
          <a:off x="2347872" y="1308235"/>
          <a:ext cx="2449732" cy="27090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5" name="Prism 9" r:id="rId6" imgW="3029375" imgH="3349443" progId="Prism9.Document">
                  <p:embed/>
                </p:oleObj>
              </mc:Choice>
              <mc:Fallback>
                <p:oleObj name="Prism 9" r:id="rId6" imgW="3029375" imgH="334944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347872" y="1308235"/>
                        <a:ext cx="2449732" cy="27090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DADD8AD-B7DA-4BAC-A815-0743849ECC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8066328"/>
              </p:ext>
            </p:extLst>
          </p:nvPr>
        </p:nvGraphicFramePr>
        <p:xfrm>
          <a:off x="4611727" y="1308235"/>
          <a:ext cx="2416350" cy="27090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6" name="Prism 9" r:id="rId8" imgW="2988340" imgH="3349443" progId="Prism9.Document">
                  <p:embed/>
                </p:oleObj>
              </mc:Choice>
              <mc:Fallback>
                <p:oleObj name="Prism 9" r:id="rId8" imgW="2988340" imgH="334944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611727" y="1308235"/>
                        <a:ext cx="2416350" cy="27090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781A256-766D-4F4B-8F2D-1E2C891A9C18}"/>
              </a:ext>
            </a:extLst>
          </p:cNvPr>
          <p:cNvSpPr txBox="1"/>
          <p:nvPr/>
        </p:nvSpPr>
        <p:spPr>
          <a:xfrm>
            <a:off x="148056" y="1360234"/>
            <a:ext cx="31452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3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62CF73-F4E9-4525-83D0-47E4E21D83E1}"/>
              </a:ext>
            </a:extLst>
          </p:cNvPr>
          <p:cNvSpPr txBox="1"/>
          <p:nvPr/>
        </p:nvSpPr>
        <p:spPr>
          <a:xfrm>
            <a:off x="2363611" y="1360234"/>
            <a:ext cx="31452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3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3FA27CE-068A-4D0F-8EF2-25589EF1A175}"/>
              </a:ext>
            </a:extLst>
          </p:cNvPr>
          <p:cNvSpPr txBox="1"/>
          <p:nvPr/>
        </p:nvSpPr>
        <p:spPr>
          <a:xfrm>
            <a:off x="4627466" y="1360234"/>
            <a:ext cx="31452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3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A2C362F-9FA3-894B-8A2D-7D0682F2BB32}"/>
              </a:ext>
            </a:extLst>
          </p:cNvPr>
          <p:cNvSpPr txBox="1"/>
          <p:nvPr/>
        </p:nvSpPr>
        <p:spPr>
          <a:xfrm>
            <a:off x="57600" y="92584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32E027-8A43-A94E-9E30-515A22440E74}"/>
              </a:ext>
            </a:extLst>
          </p:cNvPr>
          <p:cNvSpPr txBox="1"/>
          <p:nvPr/>
        </p:nvSpPr>
        <p:spPr>
          <a:xfrm>
            <a:off x="305319" y="4196138"/>
            <a:ext cx="61738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E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BE" sz="1200" b="1" dirty="0">
                <a:latin typeface="Arial" panose="020B0604020202020204" pitchFamily="34" charset="0"/>
                <a:cs typeface="Arial" panose="020B0604020202020204" pitchFamily="34" charset="0"/>
              </a:rPr>
              <a:t>Age induced increases in plasma levels of chemotactic molecules</a:t>
            </a:r>
            <a:r>
              <a:rPr lang="en-BE" sz="1200" dirty="0">
                <a:latin typeface="Arial" panose="020B0604020202020204" pitchFamily="34" charset="0"/>
                <a:cs typeface="Arial" panose="020B0604020202020204" pitchFamily="34" charset="0"/>
              </a:rPr>
              <a:t>. (A) CCL2  plasma level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 measured by Meso Scale Discovery</a:t>
            </a:r>
            <a:r>
              <a:rPr lang="en-BE" sz="1200" dirty="0">
                <a:latin typeface="Arial" panose="020B0604020202020204" pitchFamily="34" charset="0"/>
                <a:cs typeface="Arial" panose="020B0604020202020204" pitchFamily="34" charset="0"/>
              </a:rPr>
              <a:t>. (B) Peripheral concentrations of chemokine CCL3  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 measured in plasma</a:t>
            </a:r>
            <a:r>
              <a:rPr lang="en-BE" sz="1200" dirty="0">
                <a:latin typeface="Arial" panose="020B0604020202020204" pitchFamily="34" charset="0"/>
                <a:cs typeface="Arial" panose="020B0604020202020204" pitchFamily="34" charset="0"/>
              </a:rPr>
              <a:t>. (C) Plasma concentra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BE" sz="1200" dirty="0">
                <a:latin typeface="Arial" panose="020B0604020202020204" pitchFamily="34" charset="0"/>
                <a:cs typeface="Arial" panose="020B0604020202020204" pitchFamily="34" charset="0"/>
              </a:rPr>
              <a:t> of CXCL2. NS: not significant, **** P &lt; 0.0001. For young groups n = 10 – 17, for old groups n = 14 – 19. </a:t>
            </a:r>
          </a:p>
          <a:p>
            <a:endParaRPr lang="en-B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8361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77</TotalTime>
  <Words>624</Words>
  <Application>Microsoft Macintosh PowerPoint</Application>
  <PresentationFormat>A4 Paper (210x297 mm)</PresentationFormat>
  <Paragraphs>208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Aging paper</dc:title>
  <dc:creator>Stijn Van Bruggen</dc:creator>
  <cp:lastModifiedBy>Kim Martinod</cp:lastModifiedBy>
  <cp:revision>184</cp:revision>
  <dcterms:created xsi:type="dcterms:W3CDTF">2021-10-06T16:34:25Z</dcterms:created>
  <dcterms:modified xsi:type="dcterms:W3CDTF">2022-03-14T10:38:45Z</dcterms:modified>
</cp:coreProperties>
</file>